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drew French" initials="AF" lastIdx="2" clrIdx="0">
    <p:extLst>
      <p:ext uri="{19B8F6BF-5375-455C-9EA6-DF929625EA0E}">
        <p15:presenceInfo xmlns:p15="http://schemas.microsoft.com/office/powerpoint/2012/main" userId="S-1-5-21-2443529608-3098792306-3041422421-55297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120" y="7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5B3C9-DB01-4ED5-9C41-C63F6209BB10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E5E45-509D-4663-A3AA-C74626F1452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38832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5B3C9-DB01-4ED5-9C41-C63F6209BB10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E5E45-509D-4663-A3AA-C74626F1452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70522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5B3C9-DB01-4ED5-9C41-C63F6209BB10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E5E45-509D-4663-A3AA-C74626F1452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1767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5B3C9-DB01-4ED5-9C41-C63F6209BB10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E5E45-509D-4663-A3AA-C74626F1452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99646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5B3C9-DB01-4ED5-9C41-C63F6209BB10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E5E45-509D-4663-A3AA-C74626F1452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682594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5B3C9-DB01-4ED5-9C41-C63F6209BB10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E5E45-509D-4663-A3AA-C74626F1452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223417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5B3C9-DB01-4ED5-9C41-C63F6209BB10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E5E45-509D-4663-A3AA-C74626F1452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65477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5B3C9-DB01-4ED5-9C41-C63F6209BB10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E5E45-509D-4663-A3AA-C74626F1452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068333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5B3C9-DB01-4ED5-9C41-C63F6209BB10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E5E45-509D-4663-A3AA-C74626F1452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074601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5B3C9-DB01-4ED5-9C41-C63F6209BB10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E5E45-509D-4663-A3AA-C74626F1452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13302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5B3C9-DB01-4ED5-9C41-C63F6209BB10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E5E45-509D-4663-A3AA-C74626F1452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478641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C5B3C9-DB01-4ED5-9C41-C63F6209BB10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8E5E45-509D-4663-A3AA-C74626F1452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16282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4028" y="1110864"/>
            <a:ext cx="9606742" cy="5023998"/>
          </a:xfrm>
          <a:prstGeom prst="rect">
            <a:avLst/>
          </a:prstGeom>
        </p:spPr>
      </p:pic>
      <p:sp>
        <p:nvSpPr>
          <p:cNvPr id="3" name="Rettangolo 2"/>
          <p:cNvSpPr/>
          <p:nvPr/>
        </p:nvSpPr>
        <p:spPr>
          <a:xfrm>
            <a:off x="1277837" y="433125"/>
            <a:ext cx="10709565" cy="461665"/>
          </a:xfrm>
          <a:prstGeom prst="rect">
            <a:avLst/>
          </a:prstGeom>
        </p:spPr>
        <p:txBody>
          <a:bodyPr wrap="square" anchor="t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|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rmal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rves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arson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lation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efficients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ong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AD, NDVI from 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AV-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Edge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af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olling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LR)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P-value &lt;0.0001, **0.0001&lt;P-value &lt;0.001, *0.001&lt;P-value &lt;0.01.</a:t>
            </a:r>
            <a:endParaRPr lang="it-IT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Rettangolo 3"/>
          <p:cNvSpPr/>
          <p:nvPr/>
        </p:nvSpPr>
        <p:spPr>
          <a:xfrm>
            <a:off x="4919730" y="1918952"/>
            <a:ext cx="1712890" cy="7340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ttangolo 4"/>
          <p:cNvSpPr/>
          <p:nvPr/>
        </p:nvSpPr>
        <p:spPr>
          <a:xfrm>
            <a:off x="5010954" y="1918952"/>
            <a:ext cx="1712890" cy="7340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ttangolo 5"/>
          <p:cNvSpPr/>
          <p:nvPr/>
        </p:nvSpPr>
        <p:spPr>
          <a:xfrm>
            <a:off x="8147047" y="1918952"/>
            <a:ext cx="1712890" cy="7340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ttangolo 6"/>
          <p:cNvSpPr/>
          <p:nvPr/>
        </p:nvSpPr>
        <p:spPr>
          <a:xfrm>
            <a:off x="8071518" y="3351926"/>
            <a:ext cx="1712890" cy="7340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CasellaDiTesto 7"/>
          <p:cNvSpPr txBox="1"/>
          <p:nvPr/>
        </p:nvSpPr>
        <p:spPr>
          <a:xfrm>
            <a:off x="5529131" y="2004677"/>
            <a:ext cx="150890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5</a:t>
            </a:r>
            <a:endParaRPr 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CasellaDiTesto 8"/>
          <p:cNvSpPr txBox="1"/>
          <p:nvPr/>
        </p:nvSpPr>
        <p:spPr>
          <a:xfrm>
            <a:off x="8501734" y="2024390"/>
            <a:ext cx="150890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05</a:t>
            </a:r>
            <a:endParaRPr 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8501734" y="3351926"/>
            <a:ext cx="150890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06</a:t>
            </a:r>
            <a:endParaRPr 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369434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8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useppe Emanuele Condorelli</dc:creator>
  <cp:lastModifiedBy>Giuseppe Emanuele Condorelli</cp:lastModifiedBy>
  <cp:revision>15</cp:revision>
  <dcterms:created xsi:type="dcterms:W3CDTF">2017-12-20T13:46:59Z</dcterms:created>
  <dcterms:modified xsi:type="dcterms:W3CDTF">2018-05-03T07:13:07Z</dcterms:modified>
</cp:coreProperties>
</file>